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18CBD-3F00-43D9-B1F6-1E032B53AC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8A8AE1-EB01-4F19-9D87-D1F4ADF1A9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7DBE9-1A9E-4BE3-A68E-D882AE111D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2C21E-BB21-4A45-8E48-ACCE5BA054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1610CD-62E8-4A8A-A89A-F53EEFFFD9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DC2D6-92E3-4538-A650-2C9858F207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2B8AF9-C4A0-4D82-9D0B-E15D1C9E20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27227-4EA5-4211-8F8D-2126E601F4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8E06E-B2EF-4A45-A194-0018B91166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5087C-25B1-4EA0-B2AE-195C9DC996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F687D9-7C02-4A7C-A4A1-620C501A32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E3802-A952-4ED4-848A-9289A03301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908452-6138-40A7-9FC9-773191A76828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subTitle"/>
          </p:nvPr>
        </p:nvSpPr>
        <p:spPr>
          <a:xfrm>
            <a:off x="323640" y="4149360"/>
            <a:ext cx="8569080" cy="2303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algn="just">
              <a:lnSpc>
                <a:spcPct val="8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2. Syndecan-1 siRNA knockdown reduces LRP-6 expression in membrane fractions of MCF-7 and MDA-MB-231 cells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2 x 10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</a:rPr>
              <a:t>5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MDA-MB-231 or MCF-7 cells were plated in a 6-well plate, incubated overnight in normal growth medium, and transfected with control and Sdc-1 siRNA after 24h. Post 24h, the transfection media were replaced with growth media containing 10% FCS. For separation of subcellular cytosolic and membrane fractions, the cells were washed twice with ice-cold PBS and lysed in ice cold 100 μl fractionation lysis buffer/well  containing proteases inhibitors. Cells were scraped with a cell scraper and collected in an Eppendorf tube. The cells were then disrupted by 6-7 cycles of freezing in liquid nitrogen and thawing at 37°C. The crude lysate was subjected to centrifugation at 100,000 ×g for 30 min at 4°C and the supernatant was collected as the cytosolic fraction. Pellets were resuspended, and membrane proteins were homogenized in 100 μl of lysis buffer containing 2% Triton X-114. The homogenate was centrifuged at 800 ×g for 10 min. The membrane fraction was separated by SDS-PAGE and immunoblotted probing for LRP-6 and TLR4 as a loading control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4"/>
          <p:cNvGraphicFramePr/>
          <p:nvPr/>
        </p:nvGraphicFramePr>
        <p:xfrm>
          <a:off x="1763640" y="115920"/>
          <a:ext cx="6193080" cy="39322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63640" y="115920"/>
                    <a:ext cx="6193080" cy="3932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8T15:32:45Z</dcterms:created>
  <dc:creator>Admin</dc:creator>
  <dc:description/>
  <dc:language>en-US</dc:language>
  <cp:lastModifiedBy>Greve</cp:lastModifiedBy>
  <dcterms:modified xsi:type="dcterms:W3CDTF">2013-12-11T11:37:09Z</dcterms:modified>
  <cp:revision>3</cp:revision>
  <dc:subject/>
  <dc:title>Folie 1</dc:title>
</cp:coreProperties>
</file>